
<file path=[Content_Types].xml><?xml version="1.0" encoding="utf-8"?>
<Types xmlns="http://schemas.openxmlformats.org/package/2006/content-types"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0"/>
  </p:notesMasterIdLst>
  <p:sldIdLst>
    <p:sldId id="256" r:id="rId5"/>
    <p:sldId id="265" r:id="rId6"/>
    <p:sldId id="262" r:id="rId7"/>
    <p:sldId id="278" r:id="rId8"/>
    <p:sldId id="280" r:id="rId9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5B0780-9231-0F41-5BA5-72A9088D43CB}" name="Nassif Rausseo,Barbara M" initials="NRM" userId="S::BMNassif@mdanderson.org::0c945e4c-5eb0-4ac7-9dfc-4ead09bee9f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4472C4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49" autoAdjust="0"/>
    <p:restoredTop sz="94660"/>
  </p:normalViewPr>
  <p:slideViewPr>
    <p:cSldViewPr snapToGrid="0">
      <p:cViewPr varScale="1">
        <p:scale>
          <a:sx n="73" d="100"/>
          <a:sy n="73" d="100"/>
        </p:scale>
        <p:origin x="30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91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8/10/relationships/authors" Target="author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nnemann,Heather Marie" userId="5168e13b-c4c4-4b4c-a312-6145703c890a" providerId="ADAL" clId="{40AF9C0E-8493-4B2F-A602-DAFAA1A618F3}"/>
    <pc:docChg chg="delSld">
      <pc:chgData name="Sonnemann,Heather Marie" userId="5168e13b-c4c4-4b4c-a312-6145703c890a" providerId="ADAL" clId="{40AF9C0E-8493-4B2F-A602-DAFAA1A618F3}" dt="2024-05-16T16:27:01.004" v="7" actId="47"/>
      <pc:docMkLst>
        <pc:docMk/>
      </pc:docMkLst>
      <pc:sldChg chg="del">
        <pc:chgData name="Sonnemann,Heather Marie" userId="5168e13b-c4c4-4b4c-a312-6145703c890a" providerId="ADAL" clId="{40AF9C0E-8493-4B2F-A602-DAFAA1A618F3}" dt="2024-05-16T16:26:51.304" v="2" actId="47"/>
        <pc:sldMkLst>
          <pc:docMk/>
          <pc:sldMk cId="2978847298" sldId="258"/>
        </pc:sldMkLst>
      </pc:sldChg>
      <pc:sldChg chg="del">
        <pc:chgData name="Sonnemann,Heather Marie" userId="5168e13b-c4c4-4b4c-a312-6145703c890a" providerId="ADAL" clId="{40AF9C0E-8493-4B2F-A602-DAFAA1A618F3}" dt="2024-05-16T16:26:53.560" v="4" actId="47"/>
        <pc:sldMkLst>
          <pc:docMk/>
          <pc:sldMk cId="2106979279" sldId="259"/>
        </pc:sldMkLst>
      </pc:sldChg>
      <pc:sldChg chg="del">
        <pc:chgData name="Sonnemann,Heather Marie" userId="5168e13b-c4c4-4b4c-a312-6145703c890a" providerId="ADAL" clId="{40AF9C0E-8493-4B2F-A602-DAFAA1A618F3}" dt="2024-05-16T16:27:00.178" v="6" actId="47"/>
        <pc:sldMkLst>
          <pc:docMk/>
          <pc:sldMk cId="3000948061" sldId="260"/>
        </pc:sldMkLst>
      </pc:sldChg>
      <pc:sldChg chg="del">
        <pc:chgData name="Sonnemann,Heather Marie" userId="5168e13b-c4c4-4b4c-a312-6145703c890a" providerId="ADAL" clId="{40AF9C0E-8493-4B2F-A602-DAFAA1A618F3}" dt="2024-05-16T16:26:47.133" v="0" actId="47"/>
        <pc:sldMkLst>
          <pc:docMk/>
          <pc:sldMk cId="3834619435" sldId="263"/>
        </pc:sldMkLst>
      </pc:sldChg>
      <pc:sldChg chg="del">
        <pc:chgData name="Sonnemann,Heather Marie" userId="5168e13b-c4c4-4b4c-a312-6145703c890a" providerId="ADAL" clId="{40AF9C0E-8493-4B2F-A602-DAFAA1A618F3}" dt="2024-05-16T16:26:47.897" v="1" actId="47"/>
        <pc:sldMkLst>
          <pc:docMk/>
          <pc:sldMk cId="1247717659" sldId="275"/>
        </pc:sldMkLst>
      </pc:sldChg>
      <pc:sldChg chg="del">
        <pc:chgData name="Sonnemann,Heather Marie" userId="5168e13b-c4c4-4b4c-a312-6145703c890a" providerId="ADAL" clId="{40AF9C0E-8493-4B2F-A602-DAFAA1A618F3}" dt="2024-05-16T16:26:52.112" v="3" actId="47"/>
        <pc:sldMkLst>
          <pc:docMk/>
          <pc:sldMk cId="1503401512" sldId="276"/>
        </pc:sldMkLst>
      </pc:sldChg>
      <pc:sldChg chg="del">
        <pc:chgData name="Sonnemann,Heather Marie" userId="5168e13b-c4c4-4b4c-a312-6145703c890a" providerId="ADAL" clId="{40AF9C0E-8493-4B2F-A602-DAFAA1A618F3}" dt="2024-05-16T16:26:54.269" v="5" actId="47"/>
        <pc:sldMkLst>
          <pc:docMk/>
          <pc:sldMk cId="1620407956" sldId="277"/>
        </pc:sldMkLst>
      </pc:sldChg>
      <pc:sldChg chg="del">
        <pc:chgData name="Sonnemann,Heather Marie" userId="5168e13b-c4c4-4b4c-a312-6145703c890a" providerId="ADAL" clId="{40AF9C0E-8493-4B2F-A602-DAFAA1A618F3}" dt="2024-05-16T16:27:01.004" v="7" actId="47"/>
        <pc:sldMkLst>
          <pc:docMk/>
          <pc:sldMk cId="2714477375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62F16A-72E6-4BF1-A3DB-A6BEB1BD8D4B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E46020F-E3FE-4107-A983-A094375CFD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9176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46020F-E3FE-4107-A983-A094375CFD4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90647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E46020F-E3FE-4107-A983-A094375CFD4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37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743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848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9894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6653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314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3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333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7304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561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900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5802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9E42EA-230A-4DFC-B594-B5E40BF742E0}" type="datetimeFigureOut">
              <a:rPr lang="en-US" smtClean="0"/>
              <a:t>5/16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0CC1B-91C0-4C4A-876C-B6A728ED71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2373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12" Type="http://schemas.openxmlformats.org/officeDocument/2006/relationships/image" Target="../media/image1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11" Type="http://schemas.openxmlformats.org/officeDocument/2006/relationships/image" Target="../media/image11.emf"/><Relationship Id="rId5" Type="http://schemas.openxmlformats.org/officeDocument/2006/relationships/image" Target="../media/image5.png"/><Relationship Id="rId10" Type="http://schemas.openxmlformats.org/officeDocument/2006/relationships/image" Target="../media/image10.emf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75230-95E5-4B7E-AAE4-CBB1DEFDC1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596577" y="2395182"/>
            <a:ext cx="6841452" cy="1125499"/>
          </a:xfrm>
        </p:spPr>
        <p:txBody>
          <a:bodyPr>
            <a:normAutofit/>
          </a:bodyPr>
          <a:lstStyle/>
          <a:p>
            <a:r>
              <a:rPr lang="en-US" sz="2400" b="1" dirty="0"/>
              <a:t>Placental co-transcriptional activator VGLL1 </a:t>
            </a:r>
            <a:br>
              <a:rPr lang="en-US" sz="2400" b="1" dirty="0"/>
            </a:br>
            <a:r>
              <a:rPr lang="en-US" sz="2400" b="1" dirty="0"/>
              <a:t>drives tumorigenesis via increasing transcription </a:t>
            </a:r>
            <a:br>
              <a:rPr lang="en-US" sz="2400" b="1" dirty="0"/>
            </a:br>
            <a:r>
              <a:rPr lang="en-US" sz="2400" b="1" dirty="0"/>
              <a:t>of proliferation and invasion genes 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F34F1F-E2D3-41F1-9A34-605017B12C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71550" y="4042606"/>
            <a:ext cx="5829300" cy="2428451"/>
          </a:xfrm>
        </p:spPr>
        <p:txBody>
          <a:bodyPr>
            <a:normAutofit/>
          </a:bodyPr>
          <a:lstStyle/>
          <a:p>
            <a:r>
              <a:rPr lang="en-US" sz="1600" dirty="0"/>
              <a:t>Heather Sonnemann, Barbara Pazdrak, Barbara Nassif,</a:t>
            </a:r>
          </a:p>
          <a:p>
            <a:r>
              <a:rPr lang="en-US" sz="1600" dirty="0"/>
              <a:t> Lama Elzohary, Yimo Sun, Amjad </a:t>
            </a:r>
            <a:r>
              <a:rPr lang="en-US" sz="1600" dirty="0" err="1"/>
              <a:t>Talukder</a:t>
            </a:r>
            <a:r>
              <a:rPr lang="en-US" sz="1600" dirty="0"/>
              <a:t>, Arjun Katailiha</a:t>
            </a:r>
            <a:r>
              <a:rPr lang="en-US" sz="1600"/>
              <a:t>, </a:t>
            </a:r>
            <a:endParaRPr lang="en-US" sz="1600" dirty="0"/>
          </a:p>
          <a:p>
            <a:r>
              <a:rPr lang="en-US" sz="1600" dirty="0"/>
              <a:t> Krishna Bhat, and Gregory Lize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4CAED16-BAD1-B7F7-E511-105794A9AE1D}"/>
              </a:ext>
            </a:extLst>
          </p:cNvPr>
          <p:cNvSpPr txBox="1"/>
          <p:nvPr/>
        </p:nvSpPr>
        <p:spPr>
          <a:xfrm>
            <a:off x="1964520" y="8924793"/>
            <a:ext cx="3843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nuscript Figures and Figure Legends</a:t>
            </a:r>
          </a:p>
        </p:txBody>
      </p:sp>
    </p:spTree>
    <p:extLst>
      <p:ext uri="{BB962C8B-B14F-4D97-AF65-F5344CB8AC3E}">
        <p14:creationId xmlns:p14="http://schemas.microsoft.com/office/powerpoint/2010/main" val="9492296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35BE8-6E52-4F11-86D9-BEC524BB7D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18178" y="706798"/>
            <a:ext cx="6703695" cy="1944159"/>
          </a:xfrm>
        </p:spPr>
        <p:txBody>
          <a:bodyPr>
            <a:normAutofit/>
          </a:bodyPr>
          <a:lstStyle/>
          <a:p>
            <a:pPr algn="ctr">
              <a:lnSpc>
                <a:spcPct val="70000"/>
              </a:lnSpc>
            </a:pPr>
            <a:r>
              <a:rPr lang="en-US" sz="2000" b="1" dirty="0"/>
              <a:t>Supplemental Fig 1. Western blot analysis to assess </a:t>
            </a:r>
            <a:br>
              <a:rPr lang="en-US" sz="2000" b="1" dirty="0"/>
            </a:br>
            <a:r>
              <a:rPr lang="en-US" sz="2000" b="1" dirty="0"/>
              <a:t>VGLL1 expression in tumor cell lysates.</a:t>
            </a:r>
            <a:r>
              <a:rPr lang="en-US" sz="3600" dirty="0"/>
              <a:t> 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494AD6B-2BF8-DBB4-0FD1-C7CEBAD272AF}"/>
              </a:ext>
            </a:extLst>
          </p:cNvPr>
          <p:cNvGrpSpPr/>
          <p:nvPr/>
        </p:nvGrpSpPr>
        <p:grpSpPr>
          <a:xfrm>
            <a:off x="923293" y="3285036"/>
            <a:ext cx="5110060" cy="1695263"/>
            <a:chOff x="923293" y="3285036"/>
            <a:chExt cx="5110060" cy="1695263"/>
          </a:xfrm>
        </p:grpSpPr>
        <p:pic>
          <p:nvPicPr>
            <p:cNvPr id="4" name="Picture 3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0F4D7EA0-0A52-4334-8852-63D2246C28F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4737" r="70169" b="35666"/>
            <a:stretch/>
          </p:blipFill>
          <p:spPr>
            <a:xfrm>
              <a:off x="2343350" y="3647928"/>
              <a:ext cx="1932158" cy="497907"/>
            </a:xfrm>
            <a:prstGeom prst="rect">
              <a:avLst/>
            </a:prstGeom>
          </p:spPr>
        </p:pic>
        <p:pic>
          <p:nvPicPr>
            <p:cNvPr id="5" name="Picture 4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1E6F2FFC-C118-49B2-AAA6-ECF2DB24956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07" t="50439" r="26367" b="39600"/>
            <a:stretch/>
          </p:blipFill>
          <p:spPr>
            <a:xfrm>
              <a:off x="4407139" y="3638911"/>
              <a:ext cx="1465484" cy="516792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FC2C8B1-3721-4DDD-BFD3-45FC23A1F750}"/>
                </a:ext>
              </a:extLst>
            </p:cNvPr>
            <p:cNvSpPr txBox="1"/>
            <p:nvPr/>
          </p:nvSpPr>
          <p:spPr>
            <a:xfrm>
              <a:off x="1505049" y="3703045"/>
              <a:ext cx="80823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VGLL1 29kD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58F9AE7-97A1-4062-B3D3-FD31ADD56E91}"/>
                </a:ext>
              </a:extLst>
            </p:cNvPr>
            <p:cNvSpPr txBox="1"/>
            <p:nvPr/>
          </p:nvSpPr>
          <p:spPr>
            <a:xfrm>
              <a:off x="2529193" y="3285036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/>
                <a:t>SU</a:t>
              </a:r>
            </a:p>
            <a:p>
              <a:pPr algn="ctr"/>
              <a:r>
                <a:rPr lang="en-US" sz="900" b="1" dirty="0"/>
                <a:t>8686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A044EC7-4C69-4732-9D57-D27A5D940B81}"/>
                </a:ext>
              </a:extLst>
            </p:cNvPr>
            <p:cNvSpPr txBox="1"/>
            <p:nvPr/>
          </p:nvSpPr>
          <p:spPr>
            <a:xfrm>
              <a:off x="2806113" y="3286988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/>
                <a:t>PANC</a:t>
              </a:r>
            </a:p>
            <a:p>
              <a:pPr algn="ctr"/>
              <a:r>
                <a:rPr lang="en-US" sz="900" b="1" dirty="0"/>
                <a:t>1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18E13D41-EA06-436C-A913-B7B7A02EFEC2}"/>
                </a:ext>
              </a:extLst>
            </p:cNvPr>
            <p:cNvSpPr txBox="1"/>
            <p:nvPr/>
          </p:nvSpPr>
          <p:spPr>
            <a:xfrm>
              <a:off x="3104532" y="3288137"/>
              <a:ext cx="4523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PANC</a:t>
              </a:r>
            </a:p>
            <a:p>
              <a:r>
                <a:rPr lang="en-US" sz="900" b="1" dirty="0"/>
                <a:t>10.0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6C40365-58E3-437C-B85D-09F2408F8E7C}"/>
                </a:ext>
              </a:extLst>
            </p:cNvPr>
            <p:cNvSpPr txBox="1"/>
            <p:nvPr/>
          </p:nvSpPr>
          <p:spPr>
            <a:xfrm>
              <a:off x="3401331" y="3285036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err="1"/>
                <a:t>Capan</a:t>
              </a:r>
              <a:endParaRPr lang="en-US" sz="900" b="1" dirty="0"/>
            </a:p>
            <a:p>
              <a:pPr algn="ctr"/>
              <a:r>
                <a:rPr lang="en-US" sz="900" b="1" dirty="0"/>
                <a:t>1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1B3C19D-AA58-47ED-96A0-8EC8CAA5E525}"/>
                </a:ext>
              </a:extLst>
            </p:cNvPr>
            <p:cNvSpPr txBox="1"/>
            <p:nvPr/>
          </p:nvSpPr>
          <p:spPr>
            <a:xfrm>
              <a:off x="3728783" y="3286988"/>
              <a:ext cx="4860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b="1" dirty="0" err="1"/>
                <a:t>Capan</a:t>
              </a:r>
              <a:endParaRPr lang="en-US" sz="900" b="1" dirty="0"/>
            </a:p>
            <a:p>
              <a:pPr algn="ctr"/>
              <a:r>
                <a:rPr lang="en-US" sz="900" b="1" dirty="0"/>
                <a:t>2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6AB23F56-7A32-430F-8D31-EBA5EFD5BF44}"/>
                </a:ext>
              </a:extLst>
            </p:cNvPr>
            <p:cNvSpPr txBox="1"/>
            <p:nvPr/>
          </p:nvSpPr>
          <p:spPr>
            <a:xfrm>
              <a:off x="5362978" y="3373026"/>
              <a:ext cx="4555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Bewo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85B9BF6A-D080-4E5E-9D09-97A0082BA553}"/>
                </a:ext>
              </a:extLst>
            </p:cNvPr>
            <p:cNvSpPr txBox="1"/>
            <p:nvPr/>
          </p:nvSpPr>
          <p:spPr>
            <a:xfrm>
              <a:off x="4532840" y="3373026"/>
              <a:ext cx="4187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BT2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D68FFD6C-8F18-4450-8BDB-51B69D082FA0}"/>
                </a:ext>
              </a:extLst>
            </p:cNvPr>
            <p:cNvSpPr txBox="1"/>
            <p:nvPr/>
          </p:nvSpPr>
          <p:spPr>
            <a:xfrm>
              <a:off x="4852199" y="337302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175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86E61C7-6B83-4766-BD8A-E233E1EFC29D}"/>
                </a:ext>
              </a:extLst>
            </p:cNvPr>
            <p:cNvSpPr txBox="1"/>
            <p:nvPr/>
          </p:nvSpPr>
          <p:spPr>
            <a:xfrm>
              <a:off x="5109976" y="3373026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/>
                <a:t>468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19529DE-11AD-47C2-9E12-6131DD389052}"/>
                </a:ext>
              </a:extLst>
            </p:cNvPr>
            <p:cNvSpPr txBox="1"/>
            <p:nvPr/>
          </p:nvSpPr>
          <p:spPr>
            <a:xfrm>
              <a:off x="3017251" y="4574852"/>
              <a:ext cx="76815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FF0000"/>
                  </a:solidFill>
                </a:rPr>
                <a:t>Pancreatic </a:t>
              </a:r>
            </a:p>
            <a:p>
              <a:pPr algn="ctr"/>
              <a:r>
                <a:rPr lang="en-US" sz="1000" b="1" dirty="0">
                  <a:solidFill>
                    <a:srgbClr val="FF0000"/>
                  </a:solidFill>
                </a:rPr>
                <a:t>Cancer </a:t>
              </a:r>
            </a:p>
          </p:txBody>
        </p: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55671623-DAF6-43F8-896B-97186B9FB6DD}"/>
                </a:ext>
              </a:extLst>
            </p:cNvPr>
            <p:cNvCxnSpPr>
              <a:cxnSpLocks/>
            </p:cNvCxnSpPr>
            <p:nvPr/>
          </p:nvCxnSpPr>
          <p:spPr>
            <a:xfrm>
              <a:off x="2249769" y="3828919"/>
              <a:ext cx="274320" cy="0"/>
            </a:xfrm>
            <a:prstGeom prst="straightConnector1">
              <a:avLst/>
            </a:prstGeom>
            <a:ln w="9525"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7B2E657A-140A-460C-B921-24A310D7583D}"/>
                </a:ext>
              </a:extLst>
            </p:cNvPr>
            <p:cNvCxnSpPr>
              <a:cxnSpLocks/>
            </p:cNvCxnSpPr>
            <p:nvPr/>
          </p:nvCxnSpPr>
          <p:spPr>
            <a:xfrm>
              <a:off x="2249769" y="4041609"/>
              <a:ext cx="274320" cy="0"/>
            </a:xfrm>
            <a:prstGeom prst="straightConnector1">
              <a:avLst/>
            </a:prstGeom>
            <a:ln w="9525">
              <a:tailEnd type="stealth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2BB3064F-7B81-4109-B4A1-477EDF1B1029}"/>
                </a:ext>
              </a:extLst>
            </p:cNvPr>
            <p:cNvSpPr/>
            <p:nvPr/>
          </p:nvSpPr>
          <p:spPr>
            <a:xfrm>
              <a:off x="923293" y="3918498"/>
              <a:ext cx="144462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/>
                <a:t>Non-specific band 26kD </a:t>
              </a:r>
            </a:p>
          </p:txBody>
        </p:sp>
        <p:pic>
          <p:nvPicPr>
            <p:cNvPr id="28" name="Picture 27" descr="A few pieces of paper with a few black spots&#10;&#10;Description automatically generated with medium confidence">
              <a:extLst>
                <a:ext uri="{FF2B5EF4-FFF2-40B4-BE49-F238E27FC236}">
                  <a16:creationId xmlns:a16="http://schemas.microsoft.com/office/drawing/2014/main" id="{0572B704-D5D1-E391-49B1-5093AD87BC7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138" t="53438" r="67260" b="42486"/>
            <a:stretch/>
          </p:blipFill>
          <p:spPr>
            <a:xfrm>
              <a:off x="2343350" y="4227696"/>
              <a:ext cx="1932158" cy="246218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A5C8EA8-2AFC-9EB8-5162-CC45F4BFA107}"/>
                </a:ext>
              </a:extLst>
            </p:cNvPr>
            <p:cNvSpPr txBox="1"/>
            <p:nvPr/>
          </p:nvSpPr>
          <p:spPr>
            <a:xfrm>
              <a:off x="1499443" y="4227693"/>
              <a:ext cx="85953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GAPDH 37kD</a:t>
              </a:r>
            </a:p>
          </p:txBody>
        </p:sp>
        <p:pic>
          <p:nvPicPr>
            <p:cNvPr id="31" name="Picture 30" descr="A few pieces of paper with a few black spots&#10;&#10;Description automatically generated with medium confidence">
              <a:extLst>
                <a:ext uri="{FF2B5EF4-FFF2-40B4-BE49-F238E27FC236}">
                  <a16:creationId xmlns:a16="http://schemas.microsoft.com/office/drawing/2014/main" id="{51DC9796-80B7-7BF0-8D65-44F3F3DCEF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982" t="53116" r="28825" b="42224"/>
            <a:stretch/>
          </p:blipFill>
          <p:spPr>
            <a:xfrm>
              <a:off x="4407139" y="4218677"/>
              <a:ext cx="1448486" cy="281499"/>
            </a:xfrm>
            <a:prstGeom prst="rect">
              <a:avLst/>
            </a:prstGeom>
          </p:spPr>
        </p:pic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A32C4E5D-CCF8-8F1F-F981-2E65067BA68F}"/>
                </a:ext>
              </a:extLst>
            </p:cNvPr>
            <p:cNvCxnSpPr>
              <a:cxnSpLocks/>
            </p:cNvCxnSpPr>
            <p:nvPr/>
          </p:nvCxnSpPr>
          <p:spPr>
            <a:xfrm>
              <a:off x="2640436" y="4579336"/>
              <a:ext cx="1389888" cy="0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62F79D8A-B8AE-9CE4-F413-2A97B6544F2F}"/>
                </a:ext>
              </a:extLst>
            </p:cNvPr>
            <p:cNvCxnSpPr>
              <a:cxnSpLocks/>
            </p:cNvCxnSpPr>
            <p:nvPr/>
          </p:nvCxnSpPr>
          <p:spPr>
            <a:xfrm>
              <a:off x="4628744" y="4585233"/>
              <a:ext cx="804884" cy="321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B340FF7A-B80B-B0C2-8745-F7FED4B14A97}"/>
                </a:ext>
              </a:extLst>
            </p:cNvPr>
            <p:cNvSpPr txBox="1"/>
            <p:nvPr/>
          </p:nvSpPr>
          <p:spPr>
            <a:xfrm>
              <a:off x="4789481" y="4570320"/>
              <a:ext cx="57419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00B050"/>
                  </a:solidFill>
                </a:rPr>
                <a:t>Breast </a:t>
              </a:r>
            </a:p>
            <a:p>
              <a:r>
                <a:rPr lang="en-US" sz="1000" b="1" dirty="0">
                  <a:solidFill>
                    <a:srgbClr val="00B050"/>
                  </a:solidFill>
                </a:rPr>
                <a:t>Cancer 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1F9FD1D7-E6AD-265C-63DC-C7FF1B250DF7}"/>
                </a:ext>
              </a:extLst>
            </p:cNvPr>
            <p:cNvCxnSpPr>
              <a:cxnSpLocks/>
            </p:cNvCxnSpPr>
            <p:nvPr/>
          </p:nvCxnSpPr>
          <p:spPr>
            <a:xfrm>
              <a:off x="5478728" y="4585233"/>
              <a:ext cx="274320" cy="0"/>
            </a:xfrm>
            <a:prstGeom prst="line">
              <a:avLst/>
            </a:prstGeom>
            <a:ln w="19050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063B916-656F-08BF-BB46-7917119000EC}"/>
                </a:ext>
              </a:extLst>
            </p:cNvPr>
            <p:cNvSpPr txBox="1"/>
            <p:nvPr/>
          </p:nvSpPr>
          <p:spPr>
            <a:xfrm>
              <a:off x="5362978" y="4580189"/>
              <a:ext cx="67037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>
                  <a:solidFill>
                    <a:srgbClr val="0070C0"/>
                  </a:solidFill>
                </a:rPr>
                <a:t>Placenta</a:t>
              </a:r>
              <a:r>
                <a:rPr lang="en-US" sz="1000" b="1" dirty="0">
                  <a:solidFill>
                    <a:srgbClr val="FF0000"/>
                  </a:solidFill>
                </a:rPr>
                <a:t> </a:t>
              </a:r>
            </a:p>
            <a:p>
              <a:pPr algn="ctr"/>
              <a:r>
                <a:rPr lang="en-US" sz="1000" b="1" dirty="0">
                  <a:solidFill>
                    <a:srgbClr val="0070C0"/>
                  </a:solidFill>
                </a:rPr>
                <a:t>Cancer</a:t>
              </a:r>
              <a:r>
                <a:rPr lang="en-US" sz="1000" b="1" dirty="0">
                  <a:solidFill>
                    <a:srgbClr val="FF0000"/>
                  </a:solidFill>
                </a:rPr>
                <a:t> 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C988F07B-2290-7B33-C61F-D1984832E244}"/>
              </a:ext>
            </a:extLst>
          </p:cNvPr>
          <p:cNvSpPr txBox="1"/>
          <p:nvPr/>
        </p:nvSpPr>
        <p:spPr>
          <a:xfrm>
            <a:off x="1051614" y="5993873"/>
            <a:ext cx="5636821" cy="17257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 Assessment of VGLL1 protein expression in different tumor cell lines.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umor cell lysates from native pancreatic cancer (SU8686, PANC1, PANC10.05, Capan1, Capan2), breast cancer (BT20, MDA-MB-175-VII, MDA-MB-468), and placenta cancer (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wo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cell lines were probed with anti-VGLL1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b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a Western blot analysis to assess relative VGLL1 protein expression. Although a non-specific 26kD band was observed in all cell lysates, this was easily distinguishable from the 29kD VGLL1 band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484184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00A3481D-FD3B-4546-8290-95CAF8F1E9D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3449" y="1020956"/>
            <a:ext cx="3049772" cy="2084832"/>
          </a:xfrm>
          <a:prstGeom prst="rect">
            <a:avLst/>
          </a:prstGeo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1D1E2824-81ED-47B4-BF68-681FB9FE51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43347" y="157523"/>
            <a:ext cx="7629053" cy="701771"/>
          </a:xfrm>
        </p:spPr>
        <p:txBody>
          <a:bodyPr>
            <a:noAutofit/>
          </a:bodyPr>
          <a:lstStyle/>
          <a:p>
            <a:pPr algn="ctr"/>
            <a:r>
              <a:rPr lang="en-US" sz="2000" b="1" dirty="0"/>
              <a:t>Supplemental Figure 2. VGLL1 chromatin binding occurs primarily </a:t>
            </a:r>
            <a:br>
              <a:rPr lang="en-US" sz="2000" b="1" dirty="0"/>
            </a:br>
            <a:r>
              <a:rPr lang="en-US" sz="2000" b="1" dirty="0"/>
              <a:t>within intron regions rather than promoter regions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727E6F8-FCC4-4402-9392-4304B031DFD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310"/>
          <a:stretch/>
        </p:blipFill>
        <p:spPr>
          <a:xfrm>
            <a:off x="239415" y="1088404"/>
            <a:ext cx="2686050" cy="208347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22863CD-7152-47F4-B8AA-9201F099544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558" r="10945" b="16068"/>
          <a:stretch/>
        </p:blipFill>
        <p:spPr>
          <a:xfrm>
            <a:off x="5168599" y="957057"/>
            <a:ext cx="2340197" cy="2169067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40B82D05-4E96-4ACA-A6D9-6BC37B4FEFFB}"/>
              </a:ext>
            </a:extLst>
          </p:cNvPr>
          <p:cNvSpPr txBox="1"/>
          <p:nvPr/>
        </p:nvSpPr>
        <p:spPr>
          <a:xfrm>
            <a:off x="744889" y="4229937"/>
            <a:ext cx="197739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Promoters (TSS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A1C98BB-58B1-4254-B051-362225B3790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64685" y="4716649"/>
            <a:ext cx="2028536" cy="205254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9ABD8BD6-A93B-4CE5-BEA1-CAE039C5E4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7920" y="4645841"/>
            <a:ext cx="2537358" cy="280015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3C399B76-1F8A-4617-969D-242E53C9F73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593221" y="4723517"/>
            <a:ext cx="2041778" cy="206352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BD8B394-4A6A-4D53-E483-A44F7F962D2C}"/>
              </a:ext>
            </a:extLst>
          </p:cNvPr>
          <p:cNvSpPr txBox="1"/>
          <p:nvPr/>
        </p:nvSpPr>
        <p:spPr>
          <a:xfrm>
            <a:off x="190773" y="410919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95CD7B4-7430-9359-EB24-4627BED296A5}"/>
              </a:ext>
            </a:extLst>
          </p:cNvPr>
          <p:cNvSpPr txBox="1"/>
          <p:nvPr/>
        </p:nvSpPr>
        <p:spPr>
          <a:xfrm>
            <a:off x="3414891" y="420779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1D3736-67BB-857B-A169-3848ED3B7C66}"/>
              </a:ext>
            </a:extLst>
          </p:cNvPr>
          <p:cNvSpPr txBox="1"/>
          <p:nvPr/>
        </p:nvSpPr>
        <p:spPr>
          <a:xfrm>
            <a:off x="174743" y="744599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436236B-A4D8-9BA4-5C0C-CC28904EBAB9}"/>
              </a:ext>
            </a:extLst>
          </p:cNvPr>
          <p:cNvSpPr txBox="1"/>
          <p:nvPr/>
        </p:nvSpPr>
        <p:spPr>
          <a:xfrm>
            <a:off x="185206" y="98113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33814D1C-30A8-03D4-C3D6-36FCB3E1D8B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75501" y="3192785"/>
            <a:ext cx="4227536" cy="66782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92F75D9-8D17-9225-F7EB-490FEBEEA346}"/>
              </a:ext>
            </a:extLst>
          </p:cNvPr>
          <p:cNvSpPr txBox="1"/>
          <p:nvPr/>
        </p:nvSpPr>
        <p:spPr>
          <a:xfrm>
            <a:off x="512221" y="4566616"/>
            <a:ext cx="936468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PANC10.0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26B4AB-D05C-90C5-9F3C-8C59FB73F04D}"/>
              </a:ext>
            </a:extLst>
          </p:cNvPr>
          <p:cNvSpPr txBox="1"/>
          <p:nvPr/>
        </p:nvSpPr>
        <p:spPr>
          <a:xfrm>
            <a:off x="1549315" y="4557506"/>
            <a:ext cx="64532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Bew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E191531-AB55-DA3D-FCB5-7AEA86E0BEE3}"/>
              </a:ext>
            </a:extLst>
          </p:cNvPr>
          <p:cNvSpPr txBox="1"/>
          <p:nvPr/>
        </p:nvSpPr>
        <p:spPr>
          <a:xfrm>
            <a:off x="2460503" y="4576226"/>
            <a:ext cx="50491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</a:rPr>
              <a:t>BT20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A0981D8E-7EE1-46C7-319B-E581C431DE9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9634" y="7873941"/>
            <a:ext cx="2408452" cy="1757964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7C86F723-28EC-A788-F57F-4AF18E422B8D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729438" y="7960664"/>
            <a:ext cx="2408451" cy="1658723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3DEC1C4-7D85-1AAA-80E2-35E59008165E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100346" y="7978515"/>
            <a:ext cx="2408451" cy="165339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15C97B9C-F776-3247-5EE6-E989ED3A0D2C}"/>
              </a:ext>
            </a:extLst>
          </p:cNvPr>
          <p:cNvSpPr txBox="1"/>
          <p:nvPr/>
        </p:nvSpPr>
        <p:spPr>
          <a:xfrm>
            <a:off x="1122113" y="7815329"/>
            <a:ext cx="9904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</a:rPr>
              <a:t>PANC10.05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F52F991-DE2C-5C02-8FCE-E4E049F79057}"/>
              </a:ext>
            </a:extLst>
          </p:cNvPr>
          <p:cNvSpPr txBox="1"/>
          <p:nvPr/>
        </p:nvSpPr>
        <p:spPr>
          <a:xfrm>
            <a:off x="3663919" y="7809646"/>
            <a:ext cx="608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</a:rPr>
              <a:t>BT20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CD24E3-CC38-6F68-7FF8-E7B1D585EAE0}"/>
              </a:ext>
            </a:extLst>
          </p:cNvPr>
          <p:cNvSpPr txBox="1"/>
          <p:nvPr/>
        </p:nvSpPr>
        <p:spPr>
          <a:xfrm>
            <a:off x="6086579" y="7809645"/>
            <a:ext cx="597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70C0"/>
                </a:solidFill>
              </a:rPr>
              <a:t>Bewo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F9B731A-08C7-4671-85A1-15AD058A430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17711"/>
          <a:stretch/>
        </p:blipFill>
        <p:spPr>
          <a:xfrm>
            <a:off x="2174617" y="4214639"/>
            <a:ext cx="864805" cy="3816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90441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4D2764-843A-7A2C-0A99-A0B6EB772F4E}"/>
              </a:ext>
            </a:extLst>
          </p:cNvPr>
          <p:cNvSpPr txBox="1"/>
          <p:nvPr/>
        </p:nvSpPr>
        <p:spPr>
          <a:xfrm>
            <a:off x="923482" y="1679889"/>
            <a:ext cx="5925436" cy="28337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. VGLL1 chromatin binding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ccurs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rimarily within intron regions rather than promoter regions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Pie chart of VGLL1-binding locations categorized by genomic region in PANC10.05, BT20, and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wo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umor cells shows that the preponderance of chromatin binding occurs within annotated intron regions. (B) Heatmap showing spars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GLL1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moter region binding for all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ree tumor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lines analyzed. (C) Peak-centered histogram of VGLL1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peaks comparing promotor regions and merged peaks regions. (D) Volcano plot analysis of VGLL1-regulated genes identified from the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data in two of the three tumor cell lines. A Log10 false discovery rate (FDR) of 2 was used as a cutoff that corresponds with p&lt;0.05. VGLL1-upregulated genes are shown in orange and VGLL1-downregulated genes in purple. 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920441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D8796388-80E0-5254-08A7-7DA9581FCCA2}"/>
              </a:ext>
            </a:extLst>
          </p:cNvPr>
          <p:cNvSpPr txBox="1"/>
          <p:nvPr/>
        </p:nvSpPr>
        <p:spPr>
          <a:xfrm>
            <a:off x="939255" y="1775742"/>
            <a:ext cx="5922289" cy="41238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1. List of genes bound by VGLL1 as determined by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analysis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ble contains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results for VGLL1 in PANC10.05, BT20, and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wo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umor cell lines, including lists of genes identified, chromatin-binding locations, and cell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es in which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GLL1 was identified to bind. Columns K, M, and L show cell line-specific binding, with 0 indicating that binding was not detected and 1 meaning that VGLL1 was found to bind to that gene in the indicated cell line. </a:t>
            </a: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Table 2. List of differentially expressed genes as determined by </a:t>
            </a:r>
            <a:r>
              <a:rPr lang="en-US" sz="1200" b="1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Aseq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alysis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Gs identified following siVGLL1 treatment of PANC10.05, BT20, and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ewo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re listed and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rted by gene function (transcription/nuclear function, invasion/proliferation, development,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tc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The siVGLL1-induced fold changes in transcript expression and gene expression level in transcripts per million (TPM) are shown for each cell line (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Scramble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/siVGLL1)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y highlighted boxes indicate that VGLL1 was also identified to bind at that locus in the </a:t>
            </a:r>
            <a:r>
              <a:rPr lang="en-US" sz="12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hIP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seq analysis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D044015-74AD-DE66-1FA6-0AEAC9CF9D83}"/>
              </a:ext>
            </a:extLst>
          </p:cNvPr>
          <p:cNvSpPr txBox="1"/>
          <p:nvPr/>
        </p:nvSpPr>
        <p:spPr>
          <a:xfrm>
            <a:off x="2348075" y="1042735"/>
            <a:ext cx="3244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 Descriptions</a:t>
            </a:r>
          </a:p>
        </p:txBody>
      </p:sp>
    </p:spTree>
    <p:extLst>
      <p:ext uri="{BB962C8B-B14F-4D97-AF65-F5344CB8AC3E}">
        <p14:creationId xmlns:p14="http://schemas.microsoft.com/office/powerpoint/2010/main" val="13196121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46117db0-41b1-4643-8f44-ffe669c95a10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134DEF9A8FC1541BA32E557993B475E" ma:contentTypeVersion="16" ma:contentTypeDescription="Create a new document." ma:contentTypeScope="" ma:versionID="b367e324e08b85e15abb1ce27bcda054">
  <xsd:schema xmlns:xsd="http://www.w3.org/2001/XMLSchema" xmlns:xs="http://www.w3.org/2001/XMLSchema" xmlns:p="http://schemas.microsoft.com/office/2006/metadata/properties" xmlns:ns3="46117db0-41b1-4643-8f44-ffe669c95a10" xmlns:ns4="513934ed-f59d-4578-b9c4-0467b3a71c28" targetNamespace="http://schemas.microsoft.com/office/2006/metadata/properties" ma:root="true" ma:fieldsID="18208ea301f52caf803e31bba730150d" ns3:_="" ns4:_="">
    <xsd:import namespace="46117db0-41b1-4643-8f44-ffe669c95a10"/>
    <xsd:import namespace="513934ed-f59d-4578-b9c4-0467b3a71c2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OCR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6117db0-41b1-4643-8f44-ffe669c95a1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3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OCR" ma:index="19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13934ed-f59d-4578-b9c4-0467b3a71c28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EA15866-3B89-4685-8978-7A5D3098C78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90BA2334-59B8-4481-B46F-6D298EACB707}">
  <ds:schemaRefs>
    <ds:schemaRef ds:uri="http://purl.org/dc/dcmitype/"/>
    <ds:schemaRef ds:uri="http://schemas.microsoft.com/office/infopath/2007/PartnerControls"/>
    <ds:schemaRef ds:uri="http://purl.org/dc/terms/"/>
    <ds:schemaRef ds:uri="http://schemas.microsoft.com/office/2006/metadata/properties"/>
    <ds:schemaRef ds:uri="http://www.w3.org/XML/1998/namespace"/>
    <ds:schemaRef ds:uri="513934ed-f59d-4578-b9c4-0467b3a71c28"/>
    <ds:schemaRef ds:uri="http://schemas.microsoft.com/office/2006/documentManagement/types"/>
    <ds:schemaRef ds:uri="http://schemas.openxmlformats.org/package/2006/metadata/core-properties"/>
    <ds:schemaRef ds:uri="46117db0-41b1-4643-8f44-ffe669c95a10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866BAC11-A287-4C85-82B2-DD5F2F1537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6117db0-41b1-4643-8f44-ffe669c95a10"/>
    <ds:schemaRef ds:uri="513934ed-f59d-4578-b9c4-0467b3a71c2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37</TotalTime>
  <Words>549</Words>
  <Application>Microsoft Office PowerPoint</Application>
  <PresentationFormat>Custom</PresentationFormat>
  <Paragraphs>49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lacental co-transcriptional activator VGLL1  drives tumorigenesis via increasing transcription  of proliferation and invasion genes </vt:lpstr>
      <vt:lpstr>Supplemental Fig 1. Western blot analysis to assess  VGLL1 expression in tumor cell lysates. </vt:lpstr>
      <vt:lpstr>Supplemental Figure 2. VGLL1 chromatin binding occurs primarily  within intron regions rather than promoter regions 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lacental co-transcriptional activator drives tumorigenesis via increasing transcription of proliferation and invasion genes</dc:title>
  <dc:creator>Sonnemann,Heather Marie</dc:creator>
  <cp:lastModifiedBy>Sonnemann,Heather Marie</cp:lastModifiedBy>
  <cp:revision>36</cp:revision>
  <dcterms:created xsi:type="dcterms:W3CDTF">2023-08-04T16:08:16Z</dcterms:created>
  <dcterms:modified xsi:type="dcterms:W3CDTF">2024-05-16T16:2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34DEF9A8FC1541BA32E557993B475E</vt:lpwstr>
  </property>
</Properties>
</file>